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3C30B-265B-408B-916C-A0E2B339FA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5FEF61-A3D6-4B28-A4CC-9CF61A3006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1E4B0E-B0EC-49B2-98B8-31974D3F7A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F0C59-5E6D-4832-A264-77E29C3388A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67A9D2-8B4B-4C20-807D-50301656EB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88EDD-07B2-47A1-BC70-795FB6E8AF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A5711-0BBA-4D94-B15B-F968108B01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DAD3EA-27DC-4232-8B84-55B679BB5A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84AD3-5E58-45CA-9F66-15E71B55EA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A7E590-7877-4CEB-9B36-9B8DA80AA3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91AF99-308E-4FEA-AFEF-F048202C7E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BA6AB6-18DD-4358-A4CC-BCCF1DFEFC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2B9696-0365-4E84-A790-302D485D02CF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hes ecah snail vimentin tfk"/>
          <p:cNvPicPr/>
          <p:nvPr/>
        </p:nvPicPr>
        <p:blipFill>
          <a:blip r:embed="rId1"/>
          <a:stretch/>
        </p:blipFill>
        <p:spPr>
          <a:xfrm>
            <a:off x="1042920" y="1197000"/>
            <a:ext cx="7344000" cy="5505480"/>
          </a:xfrm>
          <a:prstGeom prst="rect">
            <a:avLst/>
          </a:prstGeom>
          <a:ln w="0">
            <a:noFill/>
          </a:ln>
        </p:spPr>
      </p:pic>
      <p:sp>
        <p:nvSpPr>
          <p:cNvPr id="42" name="Text Box 6"/>
          <p:cNvSpPr/>
          <p:nvPr/>
        </p:nvSpPr>
        <p:spPr>
          <a:xfrm>
            <a:off x="1476360" y="260280"/>
            <a:ext cx="5975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Figure 5A/B;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Activation of Notch signaling is required for cholangiocarcinoma progression and is enhanced by inactivation of p53 in vivo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El Khatib M, Bozko P, Palagani V, Malek NP, Wilkens L, Plentz RR. PLoS One. 2013 Oct 30;8(10):e77433. doi: 10.1371/journal.pone.0077433. eCollection 201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8"/>
          <p:cNvSpPr/>
          <p:nvPr/>
        </p:nvSpPr>
        <p:spPr>
          <a:xfrm>
            <a:off x="4067280" y="5661000"/>
            <a:ext cx="129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TFK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Oval 9"/>
          <p:cNvSpPr/>
          <p:nvPr/>
        </p:nvSpPr>
        <p:spPr>
          <a:xfrm>
            <a:off x="755640" y="2565360"/>
            <a:ext cx="1224000" cy="100800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Oval 10"/>
          <p:cNvSpPr/>
          <p:nvPr/>
        </p:nvSpPr>
        <p:spPr>
          <a:xfrm>
            <a:off x="1116000" y="1197000"/>
            <a:ext cx="1224000" cy="100800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1"/>
          <p:cNvSpPr/>
          <p:nvPr/>
        </p:nvSpPr>
        <p:spPr>
          <a:xfrm>
            <a:off x="2627280" y="2060640"/>
            <a:ext cx="165744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2"/>
          <p:cNvSpPr/>
          <p:nvPr/>
        </p:nvSpPr>
        <p:spPr>
          <a:xfrm>
            <a:off x="2770200" y="3213000"/>
            <a:ext cx="165744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snail"/>
          <p:cNvPicPr/>
          <p:nvPr/>
        </p:nvPicPr>
        <p:blipFill>
          <a:blip r:embed="rId1"/>
          <a:stretch/>
        </p:blipFill>
        <p:spPr>
          <a:xfrm>
            <a:off x="1365120" y="1316160"/>
            <a:ext cx="6413760" cy="4227480"/>
          </a:xfrm>
          <a:prstGeom prst="rect">
            <a:avLst/>
          </a:prstGeom>
          <a:ln w="0">
            <a:noFill/>
          </a:ln>
        </p:spPr>
      </p:pic>
      <p:sp>
        <p:nvSpPr>
          <p:cNvPr id="49" name="Oval 5"/>
          <p:cNvSpPr/>
          <p:nvPr/>
        </p:nvSpPr>
        <p:spPr>
          <a:xfrm>
            <a:off x="6372360" y="3141720"/>
            <a:ext cx="1224000" cy="100800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6"/>
          <p:cNvSpPr/>
          <p:nvPr/>
        </p:nvSpPr>
        <p:spPr>
          <a:xfrm>
            <a:off x="3851280" y="3860640"/>
            <a:ext cx="208908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7"/>
          <p:cNvSpPr/>
          <p:nvPr/>
        </p:nvSpPr>
        <p:spPr>
          <a:xfrm>
            <a:off x="4067280" y="5661000"/>
            <a:ext cx="129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SZ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6"/>
          <p:cNvSpPr/>
          <p:nvPr/>
        </p:nvSpPr>
        <p:spPr>
          <a:xfrm>
            <a:off x="1476360" y="260280"/>
            <a:ext cx="5975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Figure 5A/B;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Activation of Notch signaling is required for cholangiocarcinoma progression and is enhanced by inactivation of p53 in vivo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El Khatib M, Bozko P, Palagani V, Malek NP, Wilkens L, Plentz RR. PLoS One. 2013 Oct 30;8(10):e77433. doi: 10.1371/journal.pone.0077433. eCollection 201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4" descr="ecad vimentin hes egi and ccc"/>
          <p:cNvPicPr/>
          <p:nvPr/>
        </p:nvPicPr>
        <p:blipFill>
          <a:blip r:embed="rId1"/>
          <a:stretch/>
        </p:blipFill>
        <p:spPr>
          <a:xfrm>
            <a:off x="971640" y="1116000"/>
            <a:ext cx="7200720" cy="5337360"/>
          </a:xfrm>
          <a:prstGeom prst="rect">
            <a:avLst/>
          </a:prstGeom>
          <a:ln w="0">
            <a:noFill/>
          </a:ln>
        </p:spPr>
      </p:pic>
      <p:sp>
        <p:nvSpPr>
          <p:cNvPr id="54" name="Text Box 5"/>
          <p:cNvSpPr/>
          <p:nvPr/>
        </p:nvSpPr>
        <p:spPr>
          <a:xfrm>
            <a:off x="4067280" y="5869080"/>
            <a:ext cx="129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SZ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Oval 6"/>
          <p:cNvSpPr/>
          <p:nvPr/>
        </p:nvSpPr>
        <p:spPr>
          <a:xfrm>
            <a:off x="971640" y="2413080"/>
            <a:ext cx="1224000" cy="100800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7"/>
          <p:cNvSpPr/>
          <p:nvPr/>
        </p:nvSpPr>
        <p:spPr>
          <a:xfrm>
            <a:off x="2340000" y="2781360"/>
            <a:ext cx="165564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6"/>
          <p:cNvSpPr/>
          <p:nvPr/>
        </p:nvSpPr>
        <p:spPr>
          <a:xfrm>
            <a:off x="1476360" y="260280"/>
            <a:ext cx="5975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Figure 5A/B;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Activation of Notch signaling is required for cholangiocarcinoma progression and is enhanced by inactivation of p53 in vivo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El Khatib M, Bozko P, Palagani V, Malek NP, Wilkens L, Plentz RR. PLoS One. 2013 Oct 30;8(10):e77433. doi: 10.1371/journal.pone.0077433. eCollection 201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04T08:52:49Z</dcterms:created>
  <dc:creator>Administrator</dc:creator>
  <dc:description/>
  <dc:language>en-US</dc:language>
  <cp:lastModifiedBy>Geno Urbano</cp:lastModifiedBy>
  <dcterms:modified xsi:type="dcterms:W3CDTF">2018-03-01T21:32:38Z</dcterms:modified>
  <cp:revision>16</cp:revision>
  <dc:subject/>
  <dc:title>Folie 1</dc:title>
</cp:coreProperties>
</file>